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CF1AA-516F-40DE-8280-71E5DCD53B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7191B-FCEB-4AB2-9912-AF152F646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976556462"/>
              </p:ext>
            </p:extLst>
          </p:nvPr>
        </p:nvGraphicFramePr>
        <p:xfrm>
          <a:off x="1537648" y="1371600"/>
          <a:ext cx="6234752" cy="4114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14400"/>
                <a:gridCol w="1066800"/>
                <a:gridCol w="2424752"/>
                <a:gridCol w="762000"/>
                <a:gridCol w="10668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Sl. No.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Gene name 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Primer set (5’ to 3’)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err="1" smtClean="0">
                          <a:latin typeface="Arial" pitchFamily="34" charset="0"/>
                          <a:cs typeface="Arial" pitchFamily="34" charset="0"/>
                        </a:rPr>
                        <a:t>Amplicon</a:t>
                      </a:r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 size (bp)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Annealing temperature</a:t>
                      </a:r>
                    </a:p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en-US" sz="1000" b="1" baseline="50000" dirty="0" err="1" smtClean="0">
                          <a:latin typeface="Arial" pitchFamily="34" charset="0"/>
                          <a:cs typeface="Arial" pitchFamily="34" charset="0"/>
                        </a:rPr>
                        <a:t>o</a:t>
                      </a:r>
                      <a:r>
                        <a:rPr lang="en-US" sz="1000" b="1" baseline="0" dirty="0" err="1" smtClean="0">
                          <a:latin typeface="Arial" pitchFamily="34" charset="0"/>
                          <a:cs typeface="Arial" pitchFamily="34" charset="0"/>
                        </a:rPr>
                        <a:t>C</a:t>
                      </a:r>
                      <a:r>
                        <a:rPr lang="en-US" sz="1000" b="1" baseline="0" dirty="0" smtClean="0">
                          <a:latin typeface="Arial" pitchFamily="34" charset="0"/>
                          <a:cs typeface="Arial" pitchFamily="34" charset="0"/>
                        </a:rPr>
                        <a:t>)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smtClean="0">
                          <a:latin typeface="Arial" pitchFamily="34" charset="0"/>
                          <a:cs typeface="Arial" pitchFamily="34" charset="0"/>
                        </a:rPr>
                        <a:t>L19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CGTCCTCCGCTGTGGTAAA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R:AGTACCCTTCCTCTTCCCTATGC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14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smtClean="0">
                          <a:latin typeface="Arial" pitchFamily="34" charset="0"/>
                          <a:cs typeface="Arial" pitchFamily="34" charset="0"/>
                        </a:rPr>
                        <a:t>Cyp19a1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GCTGAGAGACGTGGAGACCTG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:CTCTGTCACCAACAACAGTGTGG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78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smtClean="0">
                          <a:latin typeface="Arial" pitchFamily="34" charset="0"/>
                          <a:cs typeface="Arial" pitchFamily="34" charset="0"/>
                        </a:rPr>
                        <a:t>Era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GACCCTTCAGTGAAGCCTC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:GTCCCCAAAGCCTGGC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0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4.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smtClean="0">
                          <a:latin typeface="Arial" pitchFamily="34" charset="0"/>
                          <a:cs typeface="Arial" pitchFamily="34" charset="0"/>
                        </a:rPr>
                        <a:t>Hmgcs1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ACGATACGCTTTGGTAGTTG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:AAGCCCTCGGTCAAAAAT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57.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err="1" smtClean="0">
                          <a:latin typeface="Arial" pitchFamily="34" charset="0"/>
                          <a:cs typeface="Arial" pitchFamily="34" charset="0"/>
                        </a:rPr>
                        <a:t>Pappa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CATAGGGTCAGAGTGTGCCA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:CAGTGCAGACAATCCTCTGTACT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3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2.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smtClean="0">
                          <a:latin typeface="Arial" pitchFamily="34" charset="0"/>
                          <a:cs typeface="Arial" pitchFamily="34" charset="0"/>
                        </a:rPr>
                        <a:t>Rab27a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GGGGCAGGAGAGGTTTC</a:t>
                      </a:r>
                    </a:p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:GTGCATCTGTAGCTGGCTT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3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2.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smtClean="0">
                          <a:latin typeface="Arial" pitchFamily="34" charset="0"/>
                          <a:cs typeface="Arial" pitchFamily="34" charset="0"/>
                        </a:rPr>
                        <a:t>Igfbp5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GGAATCTGACCAAGGCCCC</a:t>
                      </a:r>
                    </a:p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:GAGAAGGCTTGCACTGCTTTCTC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46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smtClean="0">
                          <a:latin typeface="Arial" pitchFamily="34" charset="0"/>
                          <a:cs typeface="Arial" pitchFamily="34" charset="0"/>
                        </a:rPr>
                        <a:t>Igf1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CTTCAACAAGCCCACAGG</a:t>
                      </a:r>
                    </a:p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:GGGCTGGGACTTCTGAGT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96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56.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 smtClean="0">
                          <a:latin typeface="Arial" pitchFamily="34" charset="0"/>
                          <a:cs typeface="Arial" pitchFamily="34" charset="0"/>
                        </a:rPr>
                        <a:t>Igf1r</a:t>
                      </a:r>
                      <a:endParaRPr lang="en-IN" sz="100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:GAAGGAGCAGATGACATTCCTGG</a:t>
                      </a:r>
                    </a:p>
                    <a:p>
                      <a:pPr algn="ctr"/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:TCCCGCTGATCCTCGACTTGC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447800" y="957842"/>
            <a:ext cx="60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l Table 2: List of primers used for quantitative real time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qPCR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analyses </a:t>
            </a:r>
            <a:endParaRPr lang="en-IN" sz="1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2</Words>
  <Application>Microsoft Office PowerPoint</Application>
  <PresentationFormat>On-screen Show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iis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uresh</dc:creator>
  <cp:lastModifiedBy>user</cp:lastModifiedBy>
  <cp:revision>2</cp:revision>
  <dcterms:created xsi:type="dcterms:W3CDTF">2016-02-22T05:02:41Z</dcterms:created>
  <dcterms:modified xsi:type="dcterms:W3CDTF">2016-02-22T10:32:19Z</dcterms:modified>
</cp:coreProperties>
</file>